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7"/>
  </p:notesMasterIdLst>
  <p:sldIdLst>
    <p:sldId id="256" r:id="rId5"/>
    <p:sldId id="304" r:id="rId6"/>
    <p:sldId id="310" r:id="rId7"/>
    <p:sldId id="305" r:id="rId8"/>
    <p:sldId id="308" r:id="rId9"/>
    <p:sldId id="307" r:id="rId10"/>
    <p:sldId id="309" r:id="rId11"/>
    <p:sldId id="266" r:id="rId12"/>
    <p:sldId id="288" r:id="rId13"/>
    <p:sldId id="289" r:id="rId14"/>
    <p:sldId id="290" r:id="rId15"/>
    <p:sldId id="311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4073B34-D027-F6BA-CCB8-99A9DE567F26}" name="Falk, Marni J" initials="FMJ" userId="S::falkm@chop.edu::a95dce1f-32c3-4fce-b94c-c75bddd93028" providerId="AD"/>
  <p188:author id="{00AF2E3A-7489-25D8-F642-B3C3E9193AB0}" name="Stanley, Katelynn" initials="SK" userId="S::STANLEYK2@CHOP.EDU::c942d542-4110-4e3d-9b5c-f7a6a7e07de6" providerId="AD"/>
  <p188:author id="{F43AA858-D462-1A1A-7A6B-E390C531D974}" name="Rebecca Ganetzky" initials="RDG" userId="Rebecca Ganetzky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06795EC-D54A-4CB0-B86F-B054CB5A34E6}" v="12" dt="2024-08-19T15:04:35.24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91" autoAdjust="0"/>
    <p:restoredTop sz="93879" autoAdjust="0"/>
  </p:normalViewPr>
  <p:slideViewPr>
    <p:cSldViewPr snapToGrid="0">
      <p:cViewPr varScale="1">
        <p:scale>
          <a:sx n="76" d="100"/>
          <a:sy n="76" d="100"/>
        </p:scale>
        <p:origin x="126" y="7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microsoft.com/office/2018/10/relationships/authors" Target="author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microsoft.com/office/2015/10/relationships/revisionInfo" Target="revisionInfo.xml"/><Relationship Id="rId10" Type="http://schemas.openxmlformats.org/officeDocument/2006/relationships/slide" Target="slides/slide6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anley, Katelynn" userId="c942d542-4110-4e3d-9b5c-f7a6a7e07de6" providerId="ADAL" clId="{306795EC-D54A-4CB0-B86F-B054CB5A34E6}"/>
    <pc:docChg chg="undo custSel modSld">
      <pc:chgData name="Stanley, Katelynn" userId="c942d542-4110-4e3d-9b5c-f7a6a7e07de6" providerId="ADAL" clId="{306795EC-D54A-4CB0-B86F-B054CB5A34E6}" dt="2024-08-19T15:04:45.820" v="441" actId="20577"/>
      <pc:docMkLst>
        <pc:docMk/>
      </pc:docMkLst>
      <pc:sldChg chg="modSp mod">
        <pc:chgData name="Stanley, Katelynn" userId="c942d542-4110-4e3d-9b5c-f7a6a7e07de6" providerId="ADAL" clId="{306795EC-D54A-4CB0-B86F-B054CB5A34E6}" dt="2024-08-19T15:04:45.820" v="441" actId="20577"/>
        <pc:sldMkLst>
          <pc:docMk/>
          <pc:sldMk cId="3703395560" sldId="311"/>
        </pc:sldMkLst>
        <pc:graphicFrameChg chg="mod modGraphic">
          <ac:chgData name="Stanley, Katelynn" userId="c942d542-4110-4e3d-9b5c-f7a6a7e07de6" providerId="ADAL" clId="{306795EC-D54A-4CB0-B86F-B054CB5A34E6}" dt="2024-08-19T15:04:45.820" v="441" actId="20577"/>
          <ac:graphicFrameMkLst>
            <pc:docMk/>
            <pc:sldMk cId="3703395560" sldId="311"/>
            <ac:graphicFrameMk id="4" creationId="{1694871F-0D53-8BAC-147F-6D4B98B35DAA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2B910E-62D4-43B2-A353-239DBD600E26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150C2A-3ECF-46AD-8CC2-8A58D06C5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8745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150C2A-3ECF-46AD-8CC2-8A58D06C594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809009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FA38FD-A881-9E46-A765-A5765ADC4F60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1664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150C2A-3ECF-46AD-8CC2-8A58D06C594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6475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150C2A-3ECF-46AD-8CC2-8A58D06C594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7640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150C2A-3ECF-46AD-8CC2-8A58D06C594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33443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FA38FD-A881-9E46-A765-A5765ADC4F60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44400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150C2A-3ECF-46AD-8CC2-8A58D06C5942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63504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FA38FD-A881-9E46-A765-A5765ADC4F60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82808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FA38FD-A881-9E46-A765-A5765ADC4F60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55278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FA38FD-A881-9E46-A765-A5765ADC4F60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2491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750106-8805-BCAB-DA5E-F7B02F52D4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15769AF-558D-CC9E-1213-EFBAE2DFC1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743A64-81E6-6976-6504-8E7C453894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FC3BD4-DF1F-405C-9E95-63A8BE7E6231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5568A1-603A-1E39-5206-DDB0FAEDE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A1C69C-8C48-7208-6383-BDEE92FD1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2B9-4550-4EE5-97AE-315A3D4D98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4749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C37970-4E4C-1474-4367-356DF50811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F4E59D-ADD1-7616-7845-830B71B97E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1F1C0C-3E0A-B590-F83B-BE4F2D953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FC3BD4-DF1F-405C-9E95-63A8BE7E6231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24399F-F201-09A6-1BF8-2C65F8D99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92F7E2-EC21-723F-4513-EA53901AC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2B9-4550-4EE5-97AE-315A3D4D98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321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515D8A2-9E73-DBBC-B58B-234CB0F68B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089DCF-74E7-630F-B033-2132670C12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7517E7-095E-0EEB-ED9D-DCCCFBA1A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FC3BD4-DF1F-405C-9E95-63A8BE7E6231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517A79-2273-4ED3-E1B1-ADF734E678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7A1E79-4EBD-0CC4-1AE9-66D4DA48A4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2B9-4550-4EE5-97AE-315A3D4D98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204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4E5A79-BEDF-FBAE-4733-21257434B8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3CA559-5F58-C991-0367-2D19BB0FF1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11799C-E208-C076-6ED4-A60CDF03C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FC3BD4-DF1F-405C-9E95-63A8BE7E6231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7A31C3-EB8F-81B0-FF6B-827BDFF487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23C63E-CA1E-1435-B620-42C6670CE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2B9-4550-4EE5-97AE-315A3D4D98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905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8CA6D-7F3B-FEA7-AC3D-5D833FE31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793CE1-E4DA-86DD-7064-58731753DB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61A5C0-9254-F179-3F90-621FE37359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FC3BD4-DF1F-405C-9E95-63A8BE7E6231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B3D78B-F3BF-AD71-F37A-1645A8EEFA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3FDAAD-F272-FBC0-4A69-75D767F91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2B9-4550-4EE5-97AE-315A3D4D98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370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DD307A-57F8-5E05-4858-3AADCF1175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2C0D49-8E1E-940D-9817-C0F15A855B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14F0CA-3773-BCFE-EC04-C69EA31DF3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BD603F-1E19-0359-D920-488047DAEC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FC3BD4-DF1F-405C-9E95-63A8BE7E6231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AF9F7B-E614-16F3-D830-188ED13B2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485832-B924-37F8-9B1E-2F3BC78103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2B9-4550-4EE5-97AE-315A3D4D98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533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A1B1BF-C3B1-0BF6-52E6-6CD1E74CB7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AA6D22-A0B3-3F8E-A9DF-B3F0456A0D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9BEBAF-B8D6-4B89-B015-761E2B45B3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F07F962-BE38-9111-80EC-EC8FDA2026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3CFB4E9-9CEE-0AE4-9C54-053C71A51FA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AD7514-5D41-0DAF-4445-A614750C30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FC3BD4-DF1F-405C-9E95-63A8BE7E6231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0CAF9CF-BF7A-31AE-13A0-48A530D49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1C977A-B10E-EB91-949E-0DF6AC1DC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2B9-4550-4EE5-97AE-315A3D4D98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484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54FAEA-245C-09B5-E094-20C1B84F2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FAF2511-E3C1-BBF1-94E1-0130B49DF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FC3BD4-DF1F-405C-9E95-63A8BE7E6231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73415BD-6C1C-BBFA-C726-A1F88FA86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9823C4-7975-E27C-4359-360EC8E5DB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2B9-4550-4EE5-97AE-315A3D4D98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464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4D6160A-2BA2-3A47-2E0B-417285806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FC3BD4-DF1F-405C-9E95-63A8BE7E6231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0532DF5-3A93-D77F-9B20-AB3800FDAA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4F0A0E-E11B-F1C2-B451-B93EDCE54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2B9-4550-4EE5-97AE-315A3D4D98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804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80D47B-8218-0F4E-0638-FB08D0780E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010CCB-8F38-0247-BF84-F0AD26F689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761BA6-EED8-8A8F-578A-99EDC51BC5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CF0C81-3BB5-253F-0629-41D6A0E11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FC3BD4-DF1F-405C-9E95-63A8BE7E6231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EB0270-6113-A85A-B690-6A8B7F4C3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DC4926-25F5-0585-8CCD-AD83CC8D4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2B9-4550-4EE5-97AE-315A3D4D98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952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238333-8E53-1D1D-BBA9-76D1D921D4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F59ECB-B9EF-4DC3-2AE5-B1CF58D00F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4BADAA-45D0-06DB-F284-D5F092476E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BCDDDD-DA9E-5FA6-96A4-F3A8053EEC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FC3BD4-DF1F-405C-9E95-63A8BE7E6231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81EA9E-D4C6-6335-DA7C-80B361508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DA140D-68B4-A892-73EE-6921EED4E2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2B9-4550-4EE5-97AE-315A3D4D98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914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66255A7-24B8-BA11-0C93-1FDE216B8C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4F4E99-9CF3-D5EF-27DF-A37AAD8C41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1B44E5-23C1-A15F-46E4-4C222CEFD4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FC3BD4-DF1F-405C-9E95-63A8BE7E6231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BA3F54-20AB-A414-CFFA-FB8C2BF7C2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3A45A2-83DA-5FD0-D8A4-DFCB98D3C5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0262B9-4550-4EE5-97AE-315A3D4D98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414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3BDF99-4F18-BEF7-F336-404C4FC22F85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Expanding the Spectrum of SLSMD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FACF825-7243-D71C-5A32-E5BC736B146C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Appendix Figures</a:t>
            </a:r>
          </a:p>
        </p:txBody>
      </p:sp>
    </p:spTree>
    <p:extLst>
      <p:ext uri="{BB962C8B-B14F-4D97-AF65-F5344CB8AC3E}">
        <p14:creationId xmlns:p14="http://schemas.microsoft.com/office/powerpoint/2010/main" val="246757101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DA1FAC1-8AD2-48FF-AF09-FA2F71D8C073}"/>
              </a:ext>
            </a:extLst>
          </p:cNvPr>
          <p:cNvSpPr txBox="1"/>
          <p:nvPr/>
        </p:nvSpPr>
        <p:spPr>
          <a:xfrm>
            <a:off x="97971" y="1"/>
            <a:ext cx="6181106" cy="3694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1" dirty="0"/>
              <a:t>Appendix</a:t>
            </a:r>
          </a:p>
        </p:txBody>
      </p:sp>
      <p:pic>
        <p:nvPicPr>
          <p:cNvPr id="4" name="slide3" descr="Individual MFIS">
            <a:extLst>
              <a:ext uri="{FF2B5EF4-FFF2-40B4-BE49-F238E27FC236}">
                <a16:creationId xmlns:a16="http://schemas.microsoft.com/office/drawing/2014/main" id="{E2C39040-0D8D-B370-9DDF-77665E23EBB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"/>
            <a:ext cx="12192000" cy="6858000"/>
          </a:xfrm>
          <a:prstGeom prst="rect">
            <a:avLst/>
          </a:prstGeom>
        </p:spPr>
      </p:pic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6D2A6564-30AD-8414-8D64-32240FC6E818}"/>
              </a:ext>
            </a:extLst>
          </p:cNvPr>
          <p:cNvSpPr/>
          <p:nvPr/>
        </p:nvSpPr>
        <p:spPr>
          <a:xfrm>
            <a:off x="1500147" y="1637967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9BA258B2-65C2-7976-289E-0F70AC6AA07F}"/>
              </a:ext>
            </a:extLst>
          </p:cNvPr>
          <p:cNvSpPr/>
          <p:nvPr/>
        </p:nvSpPr>
        <p:spPr>
          <a:xfrm>
            <a:off x="1500147" y="3373342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5EEA8E72-6390-6F34-9D3F-3E7212934670}"/>
              </a:ext>
            </a:extLst>
          </p:cNvPr>
          <p:cNvSpPr/>
          <p:nvPr/>
        </p:nvSpPr>
        <p:spPr>
          <a:xfrm>
            <a:off x="1500147" y="5127599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EDAC2A48-4F43-5899-B301-24AAA3BC45BA}"/>
              </a:ext>
            </a:extLst>
          </p:cNvPr>
          <p:cNvSpPr/>
          <p:nvPr/>
        </p:nvSpPr>
        <p:spPr>
          <a:xfrm>
            <a:off x="7280746" y="1288111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2E403A54-6D4B-7381-2E58-589F997D5801}"/>
              </a:ext>
            </a:extLst>
          </p:cNvPr>
          <p:cNvSpPr/>
          <p:nvPr/>
        </p:nvSpPr>
        <p:spPr>
          <a:xfrm>
            <a:off x="7225086" y="2329731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0" name="Rectangle: Rounded Corners 9">
            <a:extLst>
              <a:ext uri="{FF2B5EF4-FFF2-40B4-BE49-F238E27FC236}">
                <a16:creationId xmlns:a16="http://schemas.microsoft.com/office/drawing/2014/main" id="{CF8BEF78-407E-B199-A410-0C3387064517}"/>
              </a:ext>
            </a:extLst>
          </p:cNvPr>
          <p:cNvSpPr/>
          <p:nvPr/>
        </p:nvSpPr>
        <p:spPr>
          <a:xfrm>
            <a:off x="7225086" y="3381292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0E52C84E-E710-8B5B-CCE9-6236212718C7}"/>
              </a:ext>
            </a:extLst>
          </p:cNvPr>
          <p:cNvSpPr/>
          <p:nvPr/>
        </p:nvSpPr>
        <p:spPr>
          <a:xfrm>
            <a:off x="7230387" y="4432851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2" name="Rectangle: Rounded Corners 11">
            <a:extLst>
              <a:ext uri="{FF2B5EF4-FFF2-40B4-BE49-F238E27FC236}">
                <a16:creationId xmlns:a16="http://schemas.microsoft.com/office/drawing/2014/main" id="{A0691E54-BA34-DAB8-3C20-A9727E867EEF}"/>
              </a:ext>
            </a:extLst>
          </p:cNvPr>
          <p:cNvSpPr/>
          <p:nvPr/>
        </p:nvSpPr>
        <p:spPr>
          <a:xfrm>
            <a:off x="7225086" y="5492362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D8BB277-31F9-6A48-D92F-6FFD442BD2EF}"/>
              </a:ext>
            </a:extLst>
          </p:cNvPr>
          <p:cNvSpPr txBox="1"/>
          <p:nvPr/>
        </p:nvSpPr>
        <p:spPr>
          <a:xfrm>
            <a:off x="263116" y="184795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162870890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BDD0786-B321-4072-B2C9-A78209E45EBA}"/>
              </a:ext>
            </a:extLst>
          </p:cNvPr>
          <p:cNvSpPr txBox="1"/>
          <p:nvPr/>
        </p:nvSpPr>
        <p:spPr>
          <a:xfrm>
            <a:off x="97971" y="1"/>
            <a:ext cx="6181106" cy="3694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1" dirty="0"/>
              <a:t>Appendix</a:t>
            </a:r>
          </a:p>
        </p:txBody>
      </p:sp>
      <p:pic>
        <p:nvPicPr>
          <p:cNvPr id="4" name="slide5" descr="Individual Lanskey/Karnofsky">
            <a:extLst>
              <a:ext uri="{FF2B5EF4-FFF2-40B4-BE49-F238E27FC236}">
                <a16:creationId xmlns:a16="http://schemas.microsoft.com/office/drawing/2014/main" id="{E87E9096-10E3-07DB-BF54-6D38DFA54B2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"/>
            <a:ext cx="12192000" cy="6858000"/>
          </a:xfrm>
          <a:prstGeom prst="rect">
            <a:avLst/>
          </a:prstGeom>
        </p:spPr>
      </p:pic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2647E34A-5674-BB67-A7F4-C4860CA250CB}"/>
              </a:ext>
            </a:extLst>
          </p:cNvPr>
          <p:cNvSpPr/>
          <p:nvPr/>
        </p:nvSpPr>
        <p:spPr>
          <a:xfrm>
            <a:off x="1349073" y="1637969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414580BE-7A83-3910-9C1C-9CAA3FF063B9}"/>
              </a:ext>
            </a:extLst>
          </p:cNvPr>
          <p:cNvSpPr/>
          <p:nvPr/>
        </p:nvSpPr>
        <p:spPr>
          <a:xfrm>
            <a:off x="1349073" y="3373342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42CE10DA-0CEC-4355-8423-C2CBB86F4DB8}"/>
              </a:ext>
            </a:extLst>
          </p:cNvPr>
          <p:cNvSpPr/>
          <p:nvPr/>
        </p:nvSpPr>
        <p:spPr>
          <a:xfrm>
            <a:off x="1349073" y="5115670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47B48C19-1D26-0A5A-DB13-41B620B042D3}"/>
              </a:ext>
            </a:extLst>
          </p:cNvPr>
          <p:cNvSpPr/>
          <p:nvPr/>
        </p:nvSpPr>
        <p:spPr>
          <a:xfrm>
            <a:off x="7272794" y="1184744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9FC1FC9D-DDD1-6549-F882-B7610A1058F6}"/>
              </a:ext>
            </a:extLst>
          </p:cNvPr>
          <p:cNvSpPr/>
          <p:nvPr/>
        </p:nvSpPr>
        <p:spPr>
          <a:xfrm>
            <a:off x="7272794" y="2067338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C3781E0B-F86C-3AFE-7A10-D5AF25FF55F6}"/>
              </a:ext>
            </a:extLst>
          </p:cNvPr>
          <p:cNvSpPr/>
          <p:nvPr/>
        </p:nvSpPr>
        <p:spPr>
          <a:xfrm>
            <a:off x="7272794" y="2949934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2" name="Rectangle: Rounded Corners 11">
            <a:extLst>
              <a:ext uri="{FF2B5EF4-FFF2-40B4-BE49-F238E27FC236}">
                <a16:creationId xmlns:a16="http://schemas.microsoft.com/office/drawing/2014/main" id="{1D995327-14C6-0ADF-654C-8E37994F5DF8}"/>
              </a:ext>
            </a:extLst>
          </p:cNvPr>
          <p:cNvSpPr/>
          <p:nvPr/>
        </p:nvSpPr>
        <p:spPr>
          <a:xfrm>
            <a:off x="7272794" y="3832529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3" name="Rectangle: Rounded Corners 12">
            <a:extLst>
              <a:ext uri="{FF2B5EF4-FFF2-40B4-BE49-F238E27FC236}">
                <a16:creationId xmlns:a16="http://schemas.microsoft.com/office/drawing/2014/main" id="{191E06FB-434E-091F-E3E4-9B32B5D30F81}"/>
              </a:ext>
            </a:extLst>
          </p:cNvPr>
          <p:cNvSpPr/>
          <p:nvPr/>
        </p:nvSpPr>
        <p:spPr>
          <a:xfrm>
            <a:off x="7272794" y="4695247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4" name="Rectangle: Rounded Corners 13">
            <a:extLst>
              <a:ext uri="{FF2B5EF4-FFF2-40B4-BE49-F238E27FC236}">
                <a16:creationId xmlns:a16="http://schemas.microsoft.com/office/drawing/2014/main" id="{F31A637B-FDE9-3D99-46E8-38690D722D2F}"/>
              </a:ext>
            </a:extLst>
          </p:cNvPr>
          <p:cNvSpPr/>
          <p:nvPr/>
        </p:nvSpPr>
        <p:spPr>
          <a:xfrm>
            <a:off x="7272794" y="5561939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58701E1-E341-140D-D17F-AFA5789456AE}"/>
              </a:ext>
            </a:extLst>
          </p:cNvPr>
          <p:cNvSpPr txBox="1"/>
          <p:nvPr/>
        </p:nvSpPr>
        <p:spPr>
          <a:xfrm>
            <a:off x="263116" y="184795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356277197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1694871F-0D53-8BAC-147F-6D4B98B35DA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980515053"/>
              </p:ext>
            </p:extLst>
          </p:nvPr>
        </p:nvGraphicFramePr>
        <p:xfrm>
          <a:off x="1264388" y="315951"/>
          <a:ext cx="8039102" cy="638856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33531">
                  <a:extLst>
                    <a:ext uri="{9D8B030D-6E8A-4147-A177-3AD203B41FA5}">
                      <a16:colId xmlns:a16="http://schemas.microsoft.com/office/drawing/2014/main" val="3459636537"/>
                    </a:ext>
                  </a:extLst>
                </a:gridCol>
                <a:gridCol w="755837">
                  <a:extLst>
                    <a:ext uri="{9D8B030D-6E8A-4147-A177-3AD203B41FA5}">
                      <a16:colId xmlns:a16="http://schemas.microsoft.com/office/drawing/2014/main" val="1488018151"/>
                    </a:ext>
                  </a:extLst>
                </a:gridCol>
                <a:gridCol w="1044833">
                  <a:extLst>
                    <a:ext uri="{9D8B030D-6E8A-4147-A177-3AD203B41FA5}">
                      <a16:colId xmlns:a16="http://schemas.microsoft.com/office/drawing/2014/main" val="3972174786"/>
                    </a:ext>
                  </a:extLst>
                </a:gridCol>
                <a:gridCol w="666915">
                  <a:extLst>
                    <a:ext uri="{9D8B030D-6E8A-4147-A177-3AD203B41FA5}">
                      <a16:colId xmlns:a16="http://schemas.microsoft.com/office/drawing/2014/main" val="1644215541"/>
                    </a:ext>
                  </a:extLst>
                </a:gridCol>
                <a:gridCol w="791960">
                  <a:extLst>
                    <a:ext uri="{9D8B030D-6E8A-4147-A177-3AD203B41FA5}">
                      <a16:colId xmlns:a16="http://schemas.microsoft.com/office/drawing/2014/main" val="3846908757"/>
                    </a:ext>
                  </a:extLst>
                </a:gridCol>
                <a:gridCol w="2078551">
                  <a:extLst>
                    <a:ext uri="{9D8B030D-6E8A-4147-A177-3AD203B41FA5}">
                      <a16:colId xmlns:a16="http://schemas.microsoft.com/office/drawing/2014/main" val="4249532164"/>
                    </a:ext>
                  </a:extLst>
                </a:gridCol>
                <a:gridCol w="1222678">
                  <a:extLst>
                    <a:ext uri="{9D8B030D-6E8A-4147-A177-3AD203B41FA5}">
                      <a16:colId xmlns:a16="http://schemas.microsoft.com/office/drawing/2014/main" val="799609911"/>
                    </a:ext>
                  </a:extLst>
                </a:gridCol>
                <a:gridCol w="944797">
                  <a:extLst>
                    <a:ext uri="{9D8B030D-6E8A-4147-A177-3AD203B41FA5}">
                      <a16:colId xmlns:a16="http://schemas.microsoft.com/office/drawing/2014/main" val="2626803111"/>
                    </a:ext>
                  </a:extLst>
                </a:gridCol>
              </a:tblGrid>
              <a:tr h="162468">
                <a:tc gridSpan="8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plemental Table K: Cohort 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teroplasmy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3889728717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</a:rPr>
                        <a:t>ID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</a:rPr>
                        <a:t>Phenotyp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</a:rPr>
                        <a:t>History of Pearson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</a:rPr>
                        <a:t>Tissu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 err="1">
                          <a:effectLst/>
                        </a:rPr>
                        <a:t>Heteroplasmy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</a:rPr>
                        <a:t>Delet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</a:rPr>
                        <a:t>Test Category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</a:rPr>
                        <a:t>Age at Collect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3846661882"/>
                  </a:ext>
                </a:extLst>
              </a:tr>
              <a:tr h="15601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P-SYNDROM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10776_14945DEL417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NG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0 </a:t>
                      </a:r>
                      <a:r>
                        <a:rPr lang="en-US" sz="900" u="none" strike="noStrike">
                          <a:effectLst/>
                        </a:rPr>
                        <a:t>– 1.5 </a:t>
                      </a:r>
                      <a:r>
                        <a:rPr lang="en-US" sz="900" u="none" strike="noStrike" dirty="0">
                          <a:effectLst/>
                        </a:rPr>
                        <a:t>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1515720468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P-SYNDROM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Ye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7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6141_9908DE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NG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– 3.0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3027195244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us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Unavailabl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483_13459DEL49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6 – 10 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4152211393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Bloo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483_13459DEL49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Southern Blo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0 – 1.4 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1052207307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Ye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Unavailabl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483_13459DEL49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– 10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3005479503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No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Southern Blo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– 10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879243852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629_14068DEL544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– 15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1919595161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7848_15695DEL784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- 15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984950007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Bloo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483_15335DEL685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 – 20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3948619135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Unavailabl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Unavailabl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Southern Blo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– 15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1418602210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Bucc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10901_16082del51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– 15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857140936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P-SYNDROM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Ye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7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M.11521_14425DEL290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 Pane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 – 3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4221757668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SLSMDS-NO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3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482_13460DEL49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ito-genome seq+de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1.5 – 3 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620425345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1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SLSMDS-NO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us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6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482_13460DEL49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1.5 – 3 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2171559367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Unavailabl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649_16084DEL743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6 – 10 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109912354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Unavailabl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Unavailabl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Southern Blo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– 15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1057425323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SLSMDS-NO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3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649_16084DEL743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solid stat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– 10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2911684675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Unavailabl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M.6098_15447DEL93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– 10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1127104541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CPEO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ucc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483_13459DEL49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-15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350725305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CPEO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Saliv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M:8483_13446del496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ito-genome seq+de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-15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3716682448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1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CPEO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Muscl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:8483_13446del49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err="1">
                          <a:effectLst/>
                        </a:rPr>
                        <a:t>mito</a:t>
                      </a:r>
                      <a:r>
                        <a:rPr lang="en-US" sz="900" u="none" strike="noStrike" dirty="0">
                          <a:effectLst/>
                        </a:rPr>
                        <a:t>-genome </a:t>
                      </a:r>
                      <a:r>
                        <a:rPr lang="en-US" sz="900" u="none" strike="noStrike" dirty="0" err="1">
                          <a:effectLst/>
                        </a:rPr>
                        <a:t>seq+de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-15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121445518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CPEO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us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5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M.8468_13444DEL497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NG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6 – 10 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707766052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CPEO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us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Unavailabl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9525_13980DEL34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NG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31- 35 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4020995372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1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4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M.8512_16015DEL750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-15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3483529106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us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5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512_16015DEL75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NG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-15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1182781473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2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ucc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10940_15524del458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31- 35 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1240086731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Saliv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m.10940_15524del458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NG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36 – 40 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363716039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2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KS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No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us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u="none" strike="noStrike" dirty="0">
                          <a:effectLst/>
                        </a:rPr>
                        <a:t> Unavailabl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Southern Blo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Southern Blo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-15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2184965559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2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KS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No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Bloo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u="none" strike="noStrike" dirty="0">
                          <a:effectLst/>
                        </a:rPr>
                        <a:t>M.7124_15163DEL804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GS</a:t>
                      </a: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-15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2386218043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2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KS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No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Bloo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5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M.7124_15163DEL804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err="1">
                          <a:effectLst/>
                        </a:rPr>
                        <a:t>mito</a:t>
                      </a:r>
                      <a:r>
                        <a:rPr lang="en-US" sz="900" u="none" strike="noStrike" dirty="0">
                          <a:effectLst/>
                        </a:rPr>
                        <a:t>-genome </a:t>
                      </a:r>
                      <a:r>
                        <a:rPr lang="en-US" sz="900" u="none" strike="noStrike" dirty="0" err="1">
                          <a:effectLst/>
                        </a:rPr>
                        <a:t>seq+de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16 – 20 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30014163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2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KS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No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Blo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648_16085DEL743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 err="1">
                          <a:effectLst/>
                        </a:rPr>
                        <a:t>mito</a:t>
                      </a:r>
                      <a:r>
                        <a:rPr lang="en-US" sz="900" u="none" strike="noStrike" dirty="0">
                          <a:effectLst/>
                        </a:rPr>
                        <a:t>-genome </a:t>
                      </a:r>
                      <a:r>
                        <a:rPr lang="en-US" sz="900" u="none" strike="noStrike" dirty="0" err="1">
                          <a:effectLst/>
                        </a:rPr>
                        <a:t>seq+de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16 – 20 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2851088377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CPEO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us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u="none" strike="noStrike">
                          <a:effectLst/>
                        </a:rPr>
                        <a:t> 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483_13459DEL49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NG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51 – 55 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3675615733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2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KS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Saliv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12584_15299DEL27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 – 30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2350129186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2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CPEO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us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5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ASO-qPC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 – 30 years</a:t>
                      </a: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2038755861"/>
                  </a:ext>
                </a:extLst>
              </a:tr>
              <a:tr h="194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CPEO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us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8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M.8483_13446DEL49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G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21 – 25 yea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210049944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2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SLSMDS-NO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Report 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Unavailabl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2709869119"/>
                  </a:ext>
                </a:extLst>
              </a:tr>
              <a:tr h="16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2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SLSMDS-NO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</a:rPr>
                        <a:t>Report Unavailab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Unavailabl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60" marR="5860" marT="5860" marB="0" anchor="b"/>
                </a:tc>
                <a:extLst>
                  <a:ext uri="{0D108BD9-81ED-4DB2-BD59-A6C34878D82A}">
                    <a16:rowId xmlns:a16="http://schemas.microsoft.com/office/drawing/2014/main" val="27883277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033955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39A795-FD14-C18A-260C-B968C99B2E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 dirty="0"/>
              <a:t>A. Height Z-Scores by Age</a:t>
            </a:r>
            <a:br>
              <a:rPr lang="en-US" dirty="0"/>
            </a:br>
            <a:r>
              <a:rPr lang="en-US" dirty="0"/>
              <a:t>Individual Graphs</a:t>
            </a:r>
          </a:p>
        </p:txBody>
      </p:sp>
      <p:pic>
        <p:nvPicPr>
          <p:cNvPr id="10" name="Content Placeholder 9" descr="A graph of growth hormone&#10;&#10;Description automatically generated">
            <a:extLst>
              <a:ext uri="{FF2B5EF4-FFF2-40B4-BE49-F238E27FC236}">
                <a16:creationId xmlns:a16="http://schemas.microsoft.com/office/drawing/2014/main" id="{4FF12724-DF40-590B-225B-355CD81725B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7240" y="1825625"/>
            <a:ext cx="4837520" cy="4351338"/>
          </a:xfrm>
        </p:spPr>
      </p:pic>
    </p:spTree>
    <p:extLst>
      <p:ext uri="{BB962C8B-B14F-4D97-AF65-F5344CB8AC3E}">
        <p14:creationId xmlns:p14="http://schemas.microsoft.com/office/powerpoint/2010/main" val="22872738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9F35F1-0C44-7A03-7FD2-013BE25223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. Height Z-Scores by Age</a:t>
            </a:r>
          </a:p>
        </p:txBody>
      </p:sp>
      <p:pic>
        <p:nvPicPr>
          <p:cNvPr id="5" name="Content Placeholder 4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2DF2A0E8-6F48-2747-9A1E-D3FDE5144E5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7537" y="1825625"/>
            <a:ext cx="5376925" cy="4351338"/>
          </a:xfrm>
        </p:spPr>
      </p:pic>
    </p:spTree>
    <p:extLst>
      <p:ext uri="{BB962C8B-B14F-4D97-AF65-F5344CB8AC3E}">
        <p14:creationId xmlns:p14="http://schemas.microsoft.com/office/powerpoint/2010/main" val="1822827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4A9708-55CE-09CC-7F2E-D59361E8AA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. BMI Z-Scores by Age</a:t>
            </a:r>
          </a:p>
        </p:txBody>
      </p:sp>
      <p:sp>
        <p:nvSpPr>
          <p:cNvPr id="12" name="AutoShape 4">
            <a:extLst>
              <a:ext uri="{FF2B5EF4-FFF2-40B4-BE49-F238E27FC236}">
                <a16:creationId xmlns:a16="http://schemas.microsoft.com/office/drawing/2014/main" id="{1E457C0A-F1DD-02D7-9FAE-32FA1DBEAC97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" name="AutoShape 8">
            <a:extLst>
              <a:ext uri="{FF2B5EF4-FFF2-40B4-BE49-F238E27FC236}">
                <a16:creationId xmlns:a16="http://schemas.microsoft.com/office/drawing/2014/main" id="{A7227C47-58BD-E035-2ADB-51625E5202EE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6096000" y="34290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8" name="Content Placeholder 7" descr="A graph with different colored lines&#10;&#10;Description automatically generated">
            <a:extLst>
              <a:ext uri="{FF2B5EF4-FFF2-40B4-BE49-F238E27FC236}">
                <a16:creationId xmlns:a16="http://schemas.microsoft.com/office/drawing/2014/main" id="{6A7DA5BB-930C-DD4A-9B9C-E02C666FA95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5833" y="1825625"/>
            <a:ext cx="5600333" cy="4351338"/>
          </a:xfrm>
        </p:spPr>
      </p:pic>
    </p:spTree>
    <p:extLst>
      <p:ext uri="{BB962C8B-B14F-4D97-AF65-F5344CB8AC3E}">
        <p14:creationId xmlns:p14="http://schemas.microsoft.com/office/powerpoint/2010/main" val="39890434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5A94B3-B709-DF62-DDE3-282B4B35F1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. BMI Z-Scores by Age</a:t>
            </a:r>
            <a:br>
              <a:rPr lang="en-US" dirty="0"/>
            </a:br>
            <a:r>
              <a:rPr lang="en-US" dirty="0"/>
              <a:t>Individual Graphs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E41CD274-3C18-55FB-A22C-A9F01C3CAB3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1051079" y="1825625"/>
            <a:ext cx="4844073" cy="4351338"/>
          </a:xfrm>
          <a:prstGeom prst="rect">
            <a:avLst/>
          </a:prstGeom>
        </p:spPr>
      </p:pic>
      <p:sp>
        <p:nvSpPr>
          <p:cNvPr id="7" name="AutoShape 4">
            <a:extLst>
              <a:ext uri="{FF2B5EF4-FFF2-40B4-BE49-F238E27FC236}">
                <a16:creationId xmlns:a16="http://schemas.microsoft.com/office/drawing/2014/main" id="{AFBDB392-1413-76D7-C70C-40F2227786E7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F89C628-6067-DA8C-8795-28FE69FD9E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1690689"/>
            <a:ext cx="5509812" cy="4197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43832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9B6540-9B33-ECDE-0CE8-730FBCD836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. Weight Z-Scores by Age</a:t>
            </a:r>
          </a:p>
        </p:txBody>
      </p:sp>
      <p:pic>
        <p:nvPicPr>
          <p:cNvPr id="9" name="Picture 8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D4AC0DB0-63DA-34B3-2809-E1623684C59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1071" y="1690688"/>
            <a:ext cx="6227761" cy="50677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80119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3ED1EF-F914-CBF3-4C2A-69DA15F98E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. Weight Z-Scores by Age</a:t>
            </a:r>
            <a:br>
              <a:rPr lang="en-US" dirty="0"/>
            </a:br>
            <a:r>
              <a:rPr lang="en-US" dirty="0"/>
              <a:t>Individual Graphs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12FB99FC-F4AF-BAB7-00B0-22F2C7A5806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694471" y="1921878"/>
            <a:ext cx="6760447" cy="435133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55468EE-937B-259F-E701-C9A685CBD0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39163" y="2411622"/>
            <a:ext cx="5105400" cy="3371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021158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E1766136-A0EB-5768-9F0A-4FE194800AC7}"/>
              </a:ext>
            </a:extLst>
          </p:cNvPr>
          <p:cNvGrpSpPr/>
          <p:nvPr/>
        </p:nvGrpSpPr>
        <p:grpSpPr>
          <a:xfrm>
            <a:off x="1418816" y="909279"/>
            <a:ext cx="2438400" cy="2319211"/>
            <a:chOff x="1533833" y="701983"/>
            <a:chExt cx="2438400" cy="2319211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0CA0BAB-04EF-3C4C-83A7-7DC6A86A42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32457"/>
            <a:stretch/>
          </p:blipFill>
          <p:spPr>
            <a:xfrm>
              <a:off x="1533833" y="701983"/>
              <a:ext cx="2438400" cy="1912880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A1E0304-E80A-EF63-19EE-308809739D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82503"/>
            <a:stretch/>
          </p:blipFill>
          <p:spPr>
            <a:xfrm>
              <a:off x="1533833" y="2525649"/>
              <a:ext cx="2438400" cy="495545"/>
            </a:xfrm>
            <a:prstGeom prst="rect">
              <a:avLst/>
            </a:prstGeom>
          </p:spPr>
        </p:pic>
      </p:grpSp>
      <p:pic>
        <p:nvPicPr>
          <p:cNvPr id="4" name="Picture 3">
            <a:extLst>
              <a:ext uri="{FF2B5EF4-FFF2-40B4-BE49-F238E27FC236}">
                <a16:creationId xmlns:a16="http://schemas.microsoft.com/office/drawing/2014/main" id="{0192E71F-88C9-EFDE-3EF0-26A47641F32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09266" y="3183795"/>
            <a:ext cx="9916977" cy="247924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C323DF0-E4A7-3395-47B7-3B2B09AEDC8A}"/>
              </a:ext>
            </a:extLst>
          </p:cNvPr>
          <p:cNvSpPr txBox="1"/>
          <p:nvPr/>
        </p:nvSpPr>
        <p:spPr>
          <a:xfrm>
            <a:off x="806450" y="698500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4D45624-969E-2F06-4997-0C20F60F5BF6}"/>
              </a:ext>
            </a:extLst>
          </p:cNvPr>
          <p:cNvSpPr txBox="1"/>
          <p:nvPr/>
        </p:nvSpPr>
        <p:spPr>
          <a:xfrm>
            <a:off x="834616" y="3273009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7E9347D-EB6B-3B90-C49E-288AE14F020C}"/>
              </a:ext>
            </a:extLst>
          </p:cNvPr>
          <p:cNvSpPr txBox="1"/>
          <p:nvPr/>
        </p:nvSpPr>
        <p:spPr>
          <a:xfrm>
            <a:off x="4377916" y="3336509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8969968-A9B1-7EC8-DD84-813CD6AD5F1E}"/>
              </a:ext>
            </a:extLst>
          </p:cNvPr>
          <p:cNvSpPr txBox="1"/>
          <p:nvPr/>
        </p:nvSpPr>
        <p:spPr>
          <a:xfrm>
            <a:off x="7648166" y="3273009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4</a:t>
            </a:r>
          </a:p>
        </p:txBody>
      </p:sp>
    </p:spTree>
    <p:extLst>
      <p:ext uri="{BB962C8B-B14F-4D97-AF65-F5344CB8AC3E}">
        <p14:creationId xmlns:p14="http://schemas.microsoft.com/office/powerpoint/2010/main" val="13323382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2E07406-3210-4BD3-8DDD-C754FD20E443}"/>
              </a:ext>
            </a:extLst>
          </p:cNvPr>
          <p:cNvSpPr txBox="1"/>
          <p:nvPr/>
        </p:nvSpPr>
        <p:spPr>
          <a:xfrm>
            <a:off x="97971" y="1"/>
            <a:ext cx="6181106" cy="3694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1" dirty="0"/>
              <a:t>Appendix</a:t>
            </a:r>
          </a:p>
        </p:txBody>
      </p:sp>
      <p:pic>
        <p:nvPicPr>
          <p:cNvPr id="2" name="slide4" descr="Individual QoL">
            <a:extLst>
              <a:ext uri="{FF2B5EF4-FFF2-40B4-BE49-F238E27FC236}">
                <a16:creationId xmlns:a16="http://schemas.microsoft.com/office/drawing/2014/main" id="{F4DF2286-4F9B-68CB-1252-76C3E295141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"/>
            <a:ext cx="12192000" cy="6858000"/>
          </a:xfrm>
          <a:prstGeom prst="rect">
            <a:avLst/>
          </a:prstGeom>
        </p:spPr>
      </p:pic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36153D30-3226-3A2E-5FD2-16C2FDAA358D}"/>
              </a:ext>
            </a:extLst>
          </p:cNvPr>
          <p:cNvSpPr/>
          <p:nvPr/>
        </p:nvSpPr>
        <p:spPr>
          <a:xfrm>
            <a:off x="1447139" y="1439187"/>
            <a:ext cx="257541" cy="206734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A806CE74-0440-781B-67D1-A56AA93AF93D}"/>
              </a:ext>
            </a:extLst>
          </p:cNvPr>
          <p:cNvSpPr/>
          <p:nvPr/>
        </p:nvSpPr>
        <p:spPr>
          <a:xfrm>
            <a:off x="1447139" y="2715773"/>
            <a:ext cx="257541" cy="206734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545DC375-D5D0-8ACB-E355-0F29EF1D3911}"/>
              </a:ext>
            </a:extLst>
          </p:cNvPr>
          <p:cNvSpPr/>
          <p:nvPr/>
        </p:nvSpPr>
        <p:spPr>
          <a:xfrm>
            <a:off x="1447139" y="3996741"/>
            <a:ext cx="257541" cy="206734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30531B76-C83D-19EE-5867-C11691B359E2}"/>
              </a:ext>
            </a:extLst>
          </p:cNvPr>
          <p:cNvSpPr/>
          <p:nvPr/>
        </p:nvSpPr>
        <p:spPr>
          <a:xfrm>
            <a:off x="1447139" y="5264773"/>
            <a:ext cx="257541" cy="206734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4C0DFE65-8962-340B-ECEE-33F13FE10C1D}"/>
              </a:ext>
            </a:extLst>
          </p:cNvPr>
          <p:cNvSpPr/>
          <p:nvPr/>
        </p:nvSpPr>
        <p:spPr>
          <a:xfrm>
            <a:off x="6819569" y="1244783"/>
            <a:ext cx="257541" cy="206734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0" name="Rectangle: Rounded Corners 9">
            <a:extLst>
              <a:ext uri="{FF2B5EF4-FFF2-40B4-BE49-F238E27FC236}">
                <a16:creationId xmlns:a16="http://schemas.microsoft.com/office/drawing/2014/main" id="{870A3DBF-449D-037C-8F3D-285DB882F516}"/>
              </a:ext>
            </a:extLst>
          </p:cNvPr>
          <p:cNvSpPr/>
          <p:nvPr/>
        </p:nvSpPr>
        <p:spPr>
          <a:xfrm>
            <a:off x="6819569" y="2115046"/>
            <a:ext cx="257541" cy="206734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E84B74E6-AE2E-C2AE-254C-5E2B8F4369F1}"/>
              </a:ext>
            </a:extLst>
          </p:cNvPr>
          <p:cNvSpPr/>
          <p:nvPr/>
        </p:nvSpPr>
        <p:spPr>
          <a:xfrm>
            <a:off x="6819569" y="2985311"/>
            <a:ext cx="257541" cy="206734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2" name="Rectangle: Rounded Corners 11">
            <a:extLst>
              <a:ext uri="{FF2B5EF4-FFF2-40B4-BE49-F238E27FC236}">
                <a16:creationId xmlns:a16="http://schemas.microsoft.com/office/drawing/2014/main" id="{2B0BB72C-3702-F0B5-61F9-B2D6D33213EB}"/>
              </a:ext>
            </a:extLst>
          </p:cNvPr>
          <p:cNvSpPr/>
          <p:nvPr/>
        </p:nvSpPr>
        <p:spPr>
          <a:xfrm>
            <a:off x="6819569" y="3790006"/>
            <a:ext cx="257541" cy="206734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3" name="Rectangle: Rounded Corners 12">
            <a:extLst>
              <a:ext uri="{FF2B5EF4-FFF2-40B4-BE49-F238E27FC236}">
                <a16:creationId xmlns:a16="http://schemas.microsoft.com/office/drawing/2014/main" id="{3DB30F97-A189-017F-6355-342EA321AB9E}"/>
              </a:ext>
            </a:extLst>
          </p:cNvPr>
          <p:cNvSpPr/>
          <p:nvPr/>
        </p:nvSpPr>
        <p:spPr>
          <a:xfrm>
            <a:off x="6819569" y="4731025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4" name="Rectangle: Rounded Corners 13">
            <a:extLst>
              <a:ext uri="{FF2B5EF4-FFF2-40B4-BE49-F238E27FC236}">
                <a16:creationId xmlns:a16="http://schemas.microsoft.com/office/drawing/2014/main" id="{A229C528-9C26-7A10-835D-B4BE98DE3755}"/>
              </a:ext>
            </a:extLst>
          </p:cNvPr>
          <p:cNvSpPr/>
          <p:nvPr/>
        </p:nvSpPr>
        <p:spPr>
          <a:xfrm>
            <a:off x="55660" y="2711395"/>
            <a:ext cx="257541" cy="206734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60372961-8EAC-F2CA-7E0E-D679E68E3E62}"/>
              </a:ext>
            </a:extLst>
          </p:cNvPr>
          <p:cNvSpPr/>
          <p:nvPr/>
        </p:nvSpPr>
        <p:spPr>
          <a:xfrm>
            <a:off x="6859775" y="5576627"/>
            <a:ext cx="257541" cy="111317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49EEC5B-7454-4325-5988-28CBA734159C}"/>
              </a:ext>
            </a:extLst>
          </p:cNvPr>
          <p:cNvSpPr txBox="1"/>
          <p:nvPr/>
        </p:nvSpPr>
        <p:spPr>
          <a:xfrm>
            <a:off x="231366" y="89545"/>
            <a:ext cx="74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17543558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291889A95D7FA4697FB90187AE62B1E" ma:contentTypeVersion="18" ma:contentTypeDescription="Create a new document." ma:contentTypeScope="" ma:versionID="085dbb27d2f2b4d6611e19c32abcc80d">
  <xsd:schema xmlns:xsd="http://www.w3.org/2001/XMLSchema" xmlns:xs="http://www.w3.org/2001/XMLSchema" xmlns:p="http://schemas.microsoft.com/office/2006/metadata/properties" xmlns:ns3="839ee948-5eed-4847-9cc9-f71274c75733" xmlns:ns4="bd917dbb-4b77-4af8-a158-fd34e71b5c32" targetNamespace="http://schemas.microsoft.com/office/2006/metadata/properties" ma:root="true" ma:fieldsID="65b1de592660dd89fa2ef0b4cc8d9613" ns3:_="" ns4:_="">
    <xsd:import namespace="839ee948-5eed-4847-9cc9-f71274c75733"/>
    <xsd:import namespace="bd917dbb-4b77-4af8-a158-fd34e71b5c3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_activity" minOccurs="0"/>
                <xsd:element ref="ns3:MediaLengthInSeconds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39ee948-5eed-4847-9cc9-f71274c7573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6" nillable="true" ma:displayName="Location" ma:internalName="MediaServiceLocation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d917dbb-4b77-4af8-a158-fd34e71b5c32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839ee948-5eed-4847-9cc9-f71274c75733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40EC28E4-BE07-487B-84E5-E1252BF8EA4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39ee948-5eed-4847-9cc9-f71274c75733"/>
    <ds:schemaRef ds:uri="bd917dbb-4b77-4af8-a158-fd34e71b5c3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4BFD378-F2C2-433D-AD78-E0A79BB431C9}">
  <ds:schemaRefs>
    <ds:schemaRef ds:uri="bd917dbb-4b77-4af8-a158-fd34e71b5c32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documentManagement/types"/>
    <ds:schemaRef ds:uri="839ee948-5eed-4847-9cc9-f71274c75733"/>
    <ds:schemaRef ds:uri="http://schemas.microsoft.com/office/2006/metadata/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3A485014-C1E2-4A39-A951-C99F017F238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72</TotalTime>
  <Words>585</Words>
  <Application>Microsoft Office PowerPoint</Application>
  <PresentationFormat>Widescreen</PresentationFormat>
  <Paragraphs>333</Paragraphs>
  <Slides>12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Expanding the Spectrum of SLSMDS</vt:lpstr>
      <vt:lpstr>A. Height Z-Scores by Age Individual Graphs</vt:lpstr>
      <vt:lpstr>B. Height Z-Scores by Age</vt:lpstr>
      <vt:lpstr>C. BMI Z-Scores by Age</vt:lpstr>
      <vt:lpstr>D. BMI Z-Scores by Age Individual Graphs</vt:lpstr>
      <vt:lpstr>E. Weight Z-Scores by Age</vt:lpstr>
      <vt:lpstr>F. Weight Z-Scores by Age Individual Graph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panding the Spectrum of SLSMDS</dc:title>
  <dc:creator>Stanley, Katelynn</dc:creator>
  <cp:lastModifiedBy>Stanley, Katelynn</cp:lastModifiedBy>
  <cp:revision>6</cp:revision>
  <dcterms:created xsi:type="dcterms:W3CDTF">2024-05-16T18:31:51Z</dcterms:created>
  <dcterms:modified xsi:type="dcterms:W3CDTF">2024-08-23T13:35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291889A95D7FA4697FB90187AE62B1E</vt:lpwstr>
  </property>
</Properties>
</file>